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50" d="100"/>
          <a:sy n="150" d="100"/>
        </p:scale>
        <p:origin x="96" y="-24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823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5872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2665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5562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9227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9703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5484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0457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4438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1769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1788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1F688D-3D5D-4909-9771-4D9E4E2A334B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134BE-549B-4CCD-A37A-2F3EA2CED4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6645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34" t="5900" r="12000"/>
          <a:stretch/>
        </p:blipFill>
        <p:spPr>
          <a:xfrm>
            <a:off x="813816" y="768095"/>
            <a:ext cx="5230368" cy="2529723"/>
          </a:xfrm>
          <a:prstGeom prst="rect">
            <a:avLst/>
          </a:prstGeom>
        </p:spPr>
      </p:pic>
      <p:graphicFrame>
        <p:nvGraphicFramePr>
          <p:cNvPr id="6" name="Tab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0912264"/>
              </p:ext>
            </p:extLst>
          </p:nvPr>
        </p:nvGraphicFramePr>
        <p:xfrm>
          <a:off x="471488" y="3884076"/>
          <a:ext cx="5915025" cy="3091936"/>
        </p:xfrm>
        <a:graphic>
          <a:graphicData uri="http://schemas.openxmlformats.org/drawingml/2006/table">
            <a:tbl>
              <a:tblPr/>
              <a:tblGrid>
                <a:gridCol w="2150918"/>
                <a:gridCol w="1613189"/>
                <a:gridCol w="2150918"/>
              </a:tblGrid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ransferase</a:t>
                      </a:r>
                      <a:r>
                        <a:rPr lang="es-ES" sz="8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8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activity</a:t>
                      </a:r>
                      <a:r>
                        <a:rPr lang="es-ES" sz="8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 (3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arbohydrate binding (2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tathione S-transfer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iopurine S-methyltransfer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arbohydrate derivative binding (2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mall molecule binding (3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hydrogenase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ofactor binding (2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Oxidoreductase activity (4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tinal dehydrogenase 1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Heterocyclic compound binding (3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do-keto reduct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Organic cyclic compound binding (3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Hydrolase activity (3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xyacylglutathione hydrol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ucine aminopeptid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Ion </a:t>
                      </a:r>
                      <a:r>
                        <a:rPr lang="es-ES" sz="8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binding</a:t>
                      </a:r>
                      <a:r>
                        <a:rPr lang="es-ES" sz="8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 (5)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xyacylglutathione hydrol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32"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22" marR="6722" marT="67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688279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4</TotalTime>
  <Words>108</Words>
  <Application>Microsoft Office PowerPoint</Application>
  <PresentationFormat>Presentación en pantalla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a</dc:creator>
  <cp:lastModifiedBy>alba</cp:lastModifiedBy>
  <cp:revision>4</cp:revision>
  <dcterms:created xsi:type="dcterms:W3CDTF">2016-01-07T16:42:09Z</dcterms:created>
  <dcterms:modified xsi:type="dcterms:W3CDTF">2016-01-08T13:02:10Z</dcterms:modified>
</cp:coreProperties>
</file>